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embeddings/oleObject8.bin" ContentType="application/vnd.openxmlformats-officedocument.oleObject"/>
  <Override PartName="/ppt/embeddings/oleObject9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DDE44F-9651-44AF-B726-B578D28DEFD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5F6989-EDD2-49F4-88D5-F4FD5F51AF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DE825C-9D44-4CD4-BD4C-76982994218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2A24D9-504C-4A6C-9EBD-4EEE0E9B41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BB336C-343B-423A-A325-90BBDE86B2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2C0F26-066A-4098-B2BC-A6A3329C48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B89FC6-5337-4471-A657-15C414EBC8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4C459B-7AB3-460B-ACEF-BCB406E17A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BE31A3-C21E-4C3A-A125-EEBCF25EF5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4706BC-F7D7-4889-90E2-60B1FEBB4D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B03D40-5984-4E52-8CEB-363D7C17A2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8D68FC-7EBB-4F26-9E5A-A509C4F91C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0AA84D-B841-4E6B-81EE-84C0E2857C7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png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0.png"/><Relationship Id="rId2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720800" y="495360"/>
            <a:ext cx="4301280" cy="1893960"/>
            <a:chOff x="1720800" y="495360"/>
            <a:chExt cx="4301280" cy="1893960"/>
          </a:xfrm>
        </p:grpSpPr>
        <p:sp>
          <p:nvSpPr>
            <p:cNvPr id="42" name=""/>
            <p:cNvSpPr/>
            <p:nvPr/>
          </p:nvSpPr>
          <p:spPr>
            <a:xfrm>
              <a:off x="1955160" y="495360"/>
              <a:ext cx="1821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HCT 116 (wt-p53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43" name=""/>
            <p:cNvGraphicFramePr/>
            <p:nvPr/>
          </p:nvGraphicFramePr>
          <p:xfrm>
            <a:off x="1720800" y="800280"/>
            <a:ext cx="2003400" cy="158904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44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720800" y="800280"/>
                      <a:ext cx="2003400" cy="1589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5" name=""/>
            <p:cNvGraphicFramePr/>
            <p:nvPr/>
          </p:nvGraphicFramePr>
          <p:xfrm>
            <a:off x="3848040" y="800280"/>
            <a:ext cx="1870200" cy="158904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46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3848040" y="800280"/>
                      <a:ext cx="1870200" cy="1589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7" name=""/>
            <p:cNvSpPr/>
            <p:nvPr/>
          </p:nvSpPr>
          <p:spPr>
            <a:xfrm>
              <a:off x="2665440" y="1828800"/>
              <a:ext cx="158760" cy="36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528280" y="731880"/>
              <a:ext cx="1401480" cy="946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1: 43.19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2: 37.03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S:    19.78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Sub-G1: 7.71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620600" y="725400"/>
              <a:ext cx="1401480" cy="946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1: 41.33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2: 24.34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S:   34.33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Sub-G1: 4.64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" name=""/>
          <p:cNvGrpSpPr/>
          <p:nvPr/>
        </p:nvGrpSpPr>
        <p:grpSpPr>
          <a:xfrm>
            <a:off x="1820160" y="4744440"/>
            <a:ext cx="4424040" cy="1954080"/>
            <a:chOff x="1820160" y="4744440"/>
            <a:chExt cx="4424040" cy="1954080"/>
          </a:xfrm>
        </p:grpSpPr>
        <p:sp>
          <p:nvSpPr>
            <p:cNvPr id="51" name=""/>
            <p:cNvSpPr/>
            <p:nvPr/>
          </p:nvSpPr>
          <p:spPr>
            <a:xfrm>
              <a:off x="5190480" y="6084720"/>
              <a:ext cx="1053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r>
                <a:rPr b="1" lang="el-GR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-Tubuli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5207040" y="5719680"/>
              <a:ext cx="812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-p5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229720" y="5334120"/>
              <a:ext cx="546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-p2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rot="20541600">
              <a:off x="2314800" y="4967280"/>
              <a:ext cx="1207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LNA-contro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rot="20510400">
              <a:off x="3066480" y="4981320"/>
              <a:ext cx="1238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LNA-miR21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820520" y="5126040"/>
              <a:ext cx="506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150640" y="6391440"/>
              <a:ext cx="1625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HCT 116 (wt-p53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8" name=""/>
            <p:cNvGrpSpPr/>
            <p:nvPr/>
          </p:nvGrpSpPr>
          <p:grpSpPr>
            <a:xfrm>
              <a:off x="1820160" y="5353200"/>
              <a:ext cx="438120" cy="997200"/>
              <a:chOff x="1820160" y="5353200"/>
              <a:chExt cx="438120" cy="997200"/>
            </a:xfrm>
          </p:grpSpPr>
          <p:sp>
            <p:nvSpPr>
              <p:cNvPr id="59" name=""/>
              <p:cNvSpPr/>
              <p:nvPr/>
            </p:nvSpPr>
            <p:spPr>
              <a:xfrm>
                <a:off x="1820160" y="5353200"/>
                <a:ext cx="43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21-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1820160" y="5701320"/>
                <a:ext cx="43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53-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1820160" y="6043320"/>
                <a:ext cx="43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50-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2" name=""/>
            <p:cNvSpPr/>
            <p:nvPr/>
          </p:nvSpPr>
          <p:spPr>
            <a:xfrm>
              <a:off x="3711960" y="6391440"/>
              <a:ext cx="1744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HCT 116 (null-p53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rot="20391600">
              <a:off x="3954960" y="4957920"/>
              <a:ext cx="1207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LNA-contro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rot="20370600">
              <a:off x="4658760" y="4951080"/>
              <a:ext cx="1238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LNA-miR21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5" name=""/>
            <p:cNvGrpSpPr/>
            <p:nvPr/>
          </p:nvGrpSpPr>
          <p:grpSpPr>
            <a:xfrm>
              <a:off x="2247840" y="5381640"/>
              <a:ext cx="1336680" cy="990360"/>
              <a:chOff x="2247840" y="5381640"/>
              <a:chExt cx="1336680" cy="990360"/>
            </a:xfrm>
          </p:grpSpPr>
          <p:graphicFrame>
            <p:nvGraphicFramePr>
              <p:cNvPr id="66" name=""/>
              <p:cNvGraphicFramePr/>
              <p:nvPr/>
            </p:nvGraphicFramePr>
            <p:xfrm>
              <a:off x="2247840" y="5381640"/>
              <a:ext cx="1336680" cy="270000"/>
            </p:xfrm>
            <a:graphic>
              <a:graphicData uri="http://schemas.openxmlformats.org/presentationml/2006/ole">
                <p:oleObj r:id="rId5" spid="">
                  <p:embed/>
                  <p:pic>
                    <p:nvPicPr>
                      <p:cNvPr id="67" name="" descr=""/>
                      <p:cNvPicPr/>
                      <p:nvPr/>
                    </p:nvPicPr>
                    <p:blipFill>
                      <a:blip r:embed="rId6"/>
                      <a:stretch/>
                    </p:blipFill>
                    <p:spPr>
                      <a:xfrm>
                        <a:off x="2247840" y="5381640"/>
                        <a:ext cx="1336680" cy="270000"/>
                      </a:xfrm>
                      <a:prstGeom prst="rect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68" name=""/>
              <p:cNvGraphicFramePr/>
              <p:nvPr/>
            </p:nvGraphicFramePr>
            <p:xfrm>
              <a:off x="2247840" y="5741640"/>
              <a:ext cx="1336680" cy="270000"/>
            </p:xfrm>
            <a:graphic>
              <a:graphicData uri="http://schemas.openxmlformats.org/presentationml/2006/ole">
                <p:oleObj r:id="rId7" spid="">
                  <p:embed/>
                  <p:pic>
                    <p:nvPicPr>
                      <p:cNvPr id="69" name="" descr=""/>
                      <p:cNvPicPr/>
                      <p:nvPr/>
                    </p:nvPicPr>
                    <p:blipFill>
                      <a:blip r:embed="rId8"/>
                      <a:stretch/>
                    </p:blipFill>
                    <p:spPr>
                      <a:xfrm>
                        <a:off x="2247840" y="5741640"/>
                        <a:ext cx="1336680" cy="270000"/>
                      </a:xfrm>
                      <a:prstGeom prst="rect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70" name=""/>
              <p:cNvGraphicFramePr/>
              <p:nvPr/>
            </p:nvGraphicFramePr>
            <p:xfrm>
              <a:off x="2247840" y="6102000"/>
              <a:ext cx="1336680" cy="270000"/>
            </p:xfrm>
            <a:graphic>
              <a:graphicData uri="http://schemas.openxmlformats.org/presentationml/2006/ole">
                <p:oleObj r:id="rId9" spid="">
                  <p:embed/>
                  <p:pic>
                    <p:nvPicPr>
                      <p:cNvPr id="71" name="" descr=""/>
                      <p:cNvPicPr/>
                      <p:nvPr/>
                    </p:nvPicPr>
                    <p:blipFill>
                      <a:blip r:embed="rId10"/>
                      <a:stretch/>
                    </p:blipFill>
                    <p:spPr>
                      <a:xfrm>
                        <a:off x="2247840" y="6102000"/>
                        <a:ext cx="1336680" cy="270000"/>
                      </a:xfrm>
                      <a:prstGeom prst="rect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</p:grpSp>
        <p:grpSp>
          <p:nvGrpSpPr>
            <p:cNvPr id="72" name=""/>
            <p:cNvGrpSpPr/>
            <p:nvPr/>
          </p:nvGrpSpPr>
          <p:grpSpPr>
            <a:xfrm>
              <a:off x="3848040" y="5381640"/>
              <a:ext cx="1371600" cy="990360"/>
              <a:chOff x="3848040" y="5381640"/>
              <a:chExt cx="1371600" cy="990360"/>
            </a:xfrm>
          </p:grpSpPr>
          <p:graphicFrame>
            <p:nvGraphicFramePr>
              <p:cNvPr id="73" name=""/>
              <p:cNvGraphicFramePr/>
              <p:nvPr/>
            </p:nvGraphicFramePr>
            <p:xfrm>
              <a:off x="3848040" y="6100560"/>
              <a:ext cx="1371600" cy="271440"/>
            </p:xfrm>
            <a:graphic>
              <a:graphicData uri="http://schemas.openxmlformats.org/presentationml/2006/ole">
                <p:oleObj r:id="rId11" spid="">
                  <p:embed/>
                  <p:pic>
                    <p:nvPicPr>
                      <p:cNvPr id="74" name="" descr=""/>
                      <p:cNvPicPr/>
                      <p:nvPr/>
                    </p:nvPicPr>
                    <p:blipFill>
                      <a:blip r:embed="rId12"/>
                      <a:stretch/>
                    </p:blipFill>
                    <p:spPr>
                      <a:xfrm>
                        <a:off x="3848040" y="6100560"/>
                        <a:ext cx="1371600" cy="271440"/>
                      </a:xfrm>
                      <a:prstGeom prst="rect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75" name=""/>
              <p:cNvGraphicFramePr/>
              <p:nvPr/>
            </p:nvGraphicFramePr>
            <p:xfrm>
              <a:off x="3848040" y="5381640"/>
              <a:ext cx="1371600" cy="271440"/>
            </p:xfrm>
            <a:graphic>
              <a:graphicData uri="http://schemas.openxmlformats.org/presentationml/2006/ole">
                <p:oleObj r:id="rId13" spid="">
                  <p:embed/>
                  <p:pic>
                    <p:nvPicPr>
                      <p:cNvPr id="76" name="" descr=""/>
                      <p:cNvPicPr/>
                      <p:nvPr/>
                    </p:nvPicPr>
                    <p:blipFill>
                      <a:blip r:embed="rId14"/>
                      <a:stretch/>
                    </p:blipFill>
                    <p:spPr>
                      <a:xfrm>
                        <a:off x="3848040" y="5381640"/>
                        <a:ext cx="1371600" cy="271440"/>
                      </a:xfrm>
                      <a:prstGeom prst="rect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77" name=""/>
              <p:cNvGraphicFramePr/>
              <p:nvPr/>
            </p:nvGraphicFramePr>
            <p:xfrm>
              <a:off x="3848040" y="5744160"/>
              <a:ext cx="1371600" cy="271440"/>
            </p:xfrm>
            <a:graphic>
              <a:graphicData uri="http://schemas.openxmlformats.org/presentationml/2006/ole">
                <p:oleObj r:id="rId15" spid="">
                  <p:embed/>
                  <p:pic>
                    <p:nvPicPr>
                      <p:cNvPr id="78" name="" descr=""/>
                      <p:cNvPicPr/>
                      <p:nvPr/>
                    </p:nvPicPr>
                    <p:blipFill>
                      <a:blip r:embed="rId16"/>
                      <a:stretch/>
                    </p:blipFill>
                    <p:spPr>
                      <a:xfrm>
                        <a:off x="3848040" y="5744160"/>
                        <a:ext cx="1371600" cy="271440"/>
                      </a:xfrm>
                      <a:prstGeom prst="rect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</p:grpSp>
      </p:grpSp>
      <p:grpSp>
        <p:nvGrpSpPr>
          <p:cNvPr id="79" name=""/>
          <p:cNvGrpSpPr/>
          <p:nvPr/>
        </p:nvGrpSpPr>
        <p:grpSpPr>
          <a:xfrm>
            <a:off x="1743120" y="2476440"/>
            <a:ext cx="4326840" cy="2294280"/>
            <a:chOff x="1743120" y="2476440"/>
            <a:chExt cx="4326840" cy="2294280"/>
          </a:xfrm>
        </p:grpSpPr>
        <p:grpSp>
          <p:nvGrpSpPr>
            <p:cNvPr id="80" name=""/>
            <p:cNvGrpSpPr/>
            <p:nvPr/>
          </p:nvGrpSpPr>
          <p:grpSpPr>
            <a:xfrm>
              <a:off x="1743120" y="2476440"/>
              <a:ext cx="4095720" cy="2294280"/>
              <a:chOff x="1743120" y="2476440"/>
              <a:chExt cx="4095720" cy="2294280"/>
            </a:xfrm>
          </p:grpSpPr>
          <p:sp>
            <p:nvSpPr>
              <p:cNvPr id="81" name=""/>
              <p:cNvSpPr/>
              <p:nvPr/>
            </p:nvSpPr>
            <p:spPr>
              <a:xfrm>
                <a:off x="2276640" y="4463640"/>
                <a:ext cx="35053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LNA-control                       LNA-miR21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aphicFrame>
            <p:nvGraphicFramePr>
              <p:cNvPr id="82" name=""/>
              <p:cNvGraphicFramePr/>
              <p:nvPr/>
            </p:nvGraphicFramePr>
            <p:xfrm>
              <a:off x="1743120" y="2787480"/>
              <a:ext cx="2092320" cy="1648800"/>
            </p:xfrm>
            <a:graphic>
              <a:graphicData uri="http://schemas.openxmlformats.org/presentationml/2006/ole">
                <p:oleObj r:id="rId17" spid="">
                  <p:embed/>
                  <p:pic>
                    <p:nvPicPr>
                      <p:cNvPr id="83" name="" descr=""/>
                      <p:cNvPicPr/>
                      <p:nvPr/>
                    </p:nvPicPr>
                    <p:blipFill>
                      <a:blip r:embed="rId18"/>
                      <a:stretch/>
                    </p:blipFill>
                    <p:spPr>
                      <a:xfrm>
                        <a:off x="1743120" y="2787480"/>
                        <a:ext cx="2092320" cy="16488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84" name=""/>
              <p:cNvSpPr/>
              <p:nvPr/>
            </p:nvSpPr>
            <p:spPr>
              <a:xfrm>
                <a:off x="2560320" y="2787480"/>
                <a:ext cx="1401480" cy="946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G1: 42.82%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G2: 21.72%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S:   35.46%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Sub-G1: 6.56%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aphicFrame>
            <p:nvGraphicFramePr>
              <p:cNvPr id="85" name=""/>
              <p:cNvGraphicFramePr/>
              <p:nvPr/>
            </p:nvGraphicFramePr>
            <p:xfrm>
              <a:off x="3867480" y="2787480"/>
              <a:ext cx="1971360" cy="1658520"/>
            </p:xfrm>
            <a:graphic>
              <a:graphicData uri="http://schemas.openxmlformats.org/presentationml/2006/ole">
                <p:oleObj r:id="rId19" spid="">
                  <p:embed/>
                  <p:pic>
                    <p:nvPicPr>
                      <p:cNvPr id="86" name="" descr=""/>
                      <p:cNvPicPr/>
                      <p:nvPr/>
                    </p:nvPicPr>
                    <p:blipFill>
                      <a:blip r:embed="rId20"/>
                      <a:stretch/>
                    </p:blipFill>
                    <p:spPr>
                      <a:xfrm>
                        <a:off x="3867480" y="2787480"/>
                        <a:ext cx="1971360" cy="16585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87" name=""/>
              <p:cNvSpPr/>
              <p:nvPr/>
            </p:nvSpPr>
            <p:spPr>
              <a:xfrm>
                <a:off x="1975680" y="2476440"/>
                <a:ext cx="19576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HCT 116 (null-p53)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8" name=""/>
            <p:cNvSpPr/>
            <p:nvPr/>
          </p:nvSpPr>
          <p:spPr>
            <a:xfrm>
              <a:off x="4668480" y="2800080"/>
              <a:ext cx="1401480" cy="946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1: 45.79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2: 19.83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S:    34.38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Sub-G1: 6.13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9" name=""/>
          <p:cNvSpPr/>
          <p:nvPr/>
        </p:nvSpPr>
        <p:spPr>
          <a:xfrm>
            <a:off x="1143000" y="457200"/>
            <a:ext cx="404640" cy="48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sbo</cp:lastModifiedBy>
  <dcterms:modified xsi:type="dcterms:W3CDTF">2010-04-13T18:51:24Z</dcterms:modified>
  <cp:revision>8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